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7680" autoAdjust="0"/>
  </p:normalViewPr>
  <p:slideViewPr>
    <p:cSldViewPr snapToGrid="0" snapToObjects="1">
      <p:cViewPr>
        <p:scale>
          <a:sx n="200" d="100"/>
          <a:sy n="200" d="100"/>
        </p:scale>
        <p:origin x="-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3B4F8D-D920-DB4C-A12E-6269A992E161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73A022-D5A8-C04B-84CD-292CFE6F989E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6668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604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4024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686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98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143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3853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1933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0972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18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0070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3627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048DDE-ED8D-834D-91C3-23FBF4396BAF}" type="datetimeFigureOut">
              <a:rPr lang="fr-FR" smtClean="0"/>
              <a:t>22/05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C2957-67E6-7042-ADE9-2107CEE7DD80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7625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3396343" y="754743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dirty="0">
              <a:solidFill>
                <a:srgbClr val="000000"/>
              </a:solidFill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616358" y="812800"/>
            <a:ext cx="1678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Supplemental</a:t>
            </a:r>
            <a:r>
              <a:rPr lang="fr-FR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Figure 3</a:t>
            </a:r>
            <a:endParaRPr lang="fr-FR" sz="1200" b="1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96511" y="1280885"/>
            <a:ext cx="2880000" cy="28800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46025" y="1280885"/>
            <a:ext cx="2880000" cy="28800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3829" y="1280885"/>
            <a:ext cx="2880000" cy="2880000"/>
          </a:xfrm>
          <a:prstGeom prst="rect">
            <a:avLst/>
          </a:prstGeom>
        </p:spPr>
      </p:pic>
      <p:sp>
        <p:nvSpPr>
          <p:cNvPr id="11" name="ZoneTexte 10"/>
          <p:cNvSpPr txBox="1"/>
          <p:nvPr/>
        </p:nvSpPr>
        <p:spPr>
          <a:xfrm rot="16200000">
            <a:off x="-449715" y="2554925"/>
            <a:ext cx="15629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CpG</a:t>
            </a:r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-137 </a:t>
            </a:r>
            <a:r>
              <a:rPr lang="fr-FR" sz="10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methylation</a:t>
            </a:r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(%)</a:t>
            </a:r>
            <a:endParaRPr lang="fr-FR" sz="10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5459131" y="1298014"/>
            <a:ext cx="12618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B)</a:t>
            </a:r>
            <a:r>
              <a:rPr lang="fr-FR" sz="1200" b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fr-FR" sz="1200" i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INS</a:t>
            </a:r>
            <a:r>
              <a:rPr lang="fr-FR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fr-FR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promoter</a:t>
            </a:r>
            <a:endParaRPr lang="fr-FR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232619" y="1310781"/>
            <a:ext cx="15736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A) </a:t>
            </a:r>
            <a:r>
              <a:rPr lang="fr-FR" sz="1200" i="1" dirty="0" smtClean="0">
                <a:solidFill>
                  <a:srgbClr val="000000"/>
                </a:solidFill>
                <a:latin typeface="Times New Roman"/>
                <a:cs typeface="Times New Roman"/>
              </a:rPr>
              <a:t>IGF1</a:t>
            </a:r>
            <a:r>
              <a:rPr lang="fr-FR" sz="12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P2 </a:t>
            </a:r>
            <a:r>
              <a:rPr lang="fr-FR" sz="12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promoter</a:t>
            </a:r>
            <a:endParaRPr lang="fr-FR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4135075" y="4096443"/>
            <a:ext cx="382716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rs689 </a:t>
            </a:r>
            <a:r>
              <a:rPr lang="fr-FR" sz="10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genotypes</a:t>
            </a:r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                                                             </a:t>
            </a:r>
            <a:r>
              <a:rPr lang="fr-FR" sz="1000" dirty="0">
                <a:solidFill>
                  <a:srgbClr val="000000"/>
                </a:solidFill>
                <a:latin typeface="Times New Roman"/>
                <a:cs typeface="Times New Roman"/>
              </a:rPr>
              <a:t>rs689 </a:t>
            </a:r>
            <a:r>
              <a:rPr lang="fr-FR" sz="1000" dirty="0" err="1">
                <a:solidFill>
                  <a:srgbClr val="000000"/>
                </a:solidFill>
                <a:latin typeface="Times New Roman"/>
                <a:cs typeface="Times New Roman"/>
              </a:rPr>
              <a:t>genotypes</a:t>
            </a:r>
            <a:endParaRPr lang="fr-FR" sz="10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    </a:t>
            </a:r>
            <a:endParaRPr lang="fr-FR" sz="10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1266066" y="4109210"/>
            <a:ext cx="11750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rs35767 </a:t>
            </a:r>
            <a:r>
              <a:rPr lang="fr-FR" sz="10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genotypes</a:t>
            </a:r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                                                           </a:t>
            </a:r>
            <a:endParaRPr lang="fr-FR" sz="10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6" name="ZoneTexte 15"/>
          <p:cNvSpPr txBox="1"/>
          <p:nvPr/>
        </p:nvSpPr>
        <p:spPr>
          <a:xfrm rot="16200000">
            <a:off x="2377201" y="2563392"/>
            <a:ext cx="15629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CpG</a:t>
            </a:r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-206 </a:t>
            </a:r>
            <a:r>
              <a:rPr lang="fr-FR" sz="10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methylation</a:t>
            </a:r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(%)</a:t>
            </a:r>
            <a:endParaRPr lang="fr-FR" sz="10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17" name="ZoneTexte 16"/>
          <p:cNvSpPr txBox="1"/>
          <p:nvPr/>
        </p:nvSpPr>
        <p:spPr>
          <a:xfrm rot="16200000">
            <a:off x="5233419" y="2512790"/>
            <a:ext cx="15629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CpG</a:t>
            </a:r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-180 </a:t>
            </a:r>
            <a:r>
              <a:rPr lang="fr-FR" sz="10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methylation</a:t>
            </a:r>
            <a:r>
              <a:rPr lang="fr-FR" sz="10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(%)</a:t>
            </a:r>
            <a:endParaRPr lang="fr-FR" sz="10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2" name="ZoneTexte 1"/>
          <p:cNvSpPr txBox="1"/>
          <p:nvPr/>
        </p:nvSpPr>
        <p:spPr>
          <a:xfrm>
            <a:off x="146161" y="3910128"/>
            <a:ext cx="83407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Allele</a:t>
            </a:r>
            <a:r>
              <a:rPr lang="fr-FR" sz="8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                   0.017                   0.023                     0.076                                           0.550                    0.380                     </a:t>
            </a:r>
            <a:r>
              <a:rPr lang="fr-FR" sz="800" dirty="0">
                <a:solidFill>
                  <a:srgbClr val="000000"/>
                </a:solidFill>
                <a:latin typeface="Times New Roman"/>
                <a:cs typeface="Times New Roman"/>
              </a:rPr>
              <a:t>0.068                     </a:t>
            </a:r>
            <a:r>
              <a:rPr lang="fr-FR" sz="8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                      0.550                    0.380                     </a:t>
            </a:r>
            <a:r>
              <a:rPr lang="fr-FR" sz="800" dirty="0">
                <a:solidFill>
                  <a:srgbClr val="000000"/>
                </a:solidFill>
                <a:latin typeface="Times New Roman"/>
                <a:cs typeface="Times New Roman"/>
              </a:rPr>
              <a:t>0.068                                                      </a:t>
            </a:r>
            <a:endParaRPr lang="fr-FR" sz="800" dirty="0" smtClean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fr-FR" sz="8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Frequency</a:t>
            </a:r>
            <a:r>
              <a:rPr lang="fr-FR" sz="8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 </a:t>
            </a:r>
            <a:endParaRPr lang="fr-FR" sz="8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287712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5</TotalTime>
  <Words>53</Words>
  <Application>Microsoft Macintosh PowerPoint</Application>
  <PresentationFormat>Présentation à l'écran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therine Le Stunff Le Stunff</dc:creator>
  <cp:lastModifiedBy>Catherine Le Stunff Le Stunff</cp:lastModifiedBy>
  <cp:revision>34</cp:revision>
  <cp:lastPrinted>2018-03-13T16:29:36Z</cp:lastPrinted>
  <dcterms:created xsi:type="dcterms:W3CDTF">2017-09-11T14:11:41Z</dcterms:created>
  <dcterms:modified xsi:type="dcterms:W3CDTF">2018-05-22T15:07:32Z</dcterms:modified>
</cp:coreProperties>
</file>